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0" r:id="rId2"/>
  </p:sldIdLst>
  <p:sldSz cx="13716000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5420"/>
  </p:normalViewPr>
  <p:slideViewPr>
    <p:cSldViewPr snapToGrid="0" snapToObjects="1">
      <p:cViewPr varScale="1">
        <p:scale>
          <a:sx n="60" d="100"/>
          <a:sy n="60" d="100"/>
        </p:scale>
        <p:origin x="82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enedict\Documents\Project%20XRBS\Fluorescence%20measurements%20spreadsheets\Drift%20experiment\All_DriftExps_In_on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enedict\Documents\Project%20XRBS\Fluorescence%20measurements%20spreadsheets\Drift%20experiment\All_DriftExps_In_on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FL_A</c:v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tx1"/>
              </a:solidFill>
              <a:ln w="3175">
                <a:solidFill>
                  <a:schemeClr val="tx1"/>
                </a:solidFill>
                <a:round/>
                <a:tailEnd w="med" len="sm"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hart!$C$3,Chart!$C$12,Chart!$C$21,Chart!$C$30)</c:f>
                <c:numCache>
                  <c:formatCode>General</c:formatCode>
                  <c:ptCount val="4"/>
                  <c:pt idx="0">
                    <c:v>1.4304732517259806</c:v>
                  </c:pt>
                  <c:pt idx="1">
                    <c:v>2.2149805280934234</c:v>
                  </c:pt>
                  <c:pt idx="2">
                    <c:v>3.0831010354864414</c:v>
                  </c:pt>
                  <c:pt idx="3">
                    <c:v>1.4401207645786194</c:v>
                  </c:pt>
                </c:numCache>
              </c:numRef>
            </c:plus>
            <c:minus>
              <c:numRef>
                <c:f>(Chart!$C$3,Chart!$C$12,Chart!$C$21,Chart!$C$30)</c:f>
                <c:numCache>
                  <c:formatCode>General</c:formatCode>
                  <c:ptCount val="4"/>
                  <c:pt idx="0">
                    <c:v>1.4304732517259806</c:v>
                  </c:pt>
                  <c:pt idx="1">
                    <c:v>2.2149805280934234</c:v>
                  </c:pt>
                  <c:pt idx="2">
                    <c:v>3.0831010354864414</c:v>
                  </c:pt>
                  <c:pt idx="3">
                    <c:v>1.4401207645786194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passage 1</c:v>
              </c:pt>
              <c:pt idx="1">
                <c:v> passage 2</c:v>
              </c:pt>
              <c:pt idx="2">
                <c:v> passage 3</c:v>
              </c:pt>
              <c:pt idx="3">
                <c:v> passage 4</c:v>
              </c:pt>
            </c:strLit>
          </c:cat>
          <c:val>
            <c:numRef>
              <c:f>(Chart!$B$3,Chart!$B$12,Chart!$B$21,Chart!$B$30)</c:f>
              <c:numCache>
                <c:formatCode>General</c:formatCode>
                <c:ptCount val="4"/>
                <c:pt idx="0">
                  <c:v>196.3436389</c:v>
                </c:pt>
                <c:pt idx="1">
                  <c:v>213.84266388999998</c:v>
                </c:pt>
                <c:pt idx="2">
                  <c:v>211.19164377333334</c:v>
                </c:pt>
                <c:pt idx="3">
                  <c:v>190.1486508866666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620-3B43-8342-BBAF59AB431B}"/>
            </c:ext>
          </c:extLst>
        </c:ser>
        <c:ser>
          <c:idx val="1"/>
          <c:order val="1"/>
          <c:tx>
            <c:v>T1_A</c:v>
          </c:tx>
          <c:spPr>
            <a:ln w="22225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 w="3175">
                <a:solidFill>
                  <a:schemeClr val="accent2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hart!$C$4,Chart!$C$13,Chart!$C$22,Chart!$C$31)</c:f>
                <c:numCache>
                  <c:formatCode>General</c:formatCode>
                  <c:ptCount val="4"/>
                  <c:pt idx="0">
                    <c:v>3.8638238752639356</c:v>
                  </c:pt>
                  <c:pt idx="1">
                    <c:v>5.7618501826107762</c:v>
                  </c:pt>
                  <c:pt idx="2">
                    <c:v>1.8170657874065421</c:v>
                  </c:pt>
                  <c:pt idx="3">
                    <c:v>0.50866332837499451</c:v>
                  </c:pt>
                </c:numCache>
              </c:numRef>
            </c:plus>
            <c:minus>
              <c:numRef>
                <c:f>(Chart!$C$4,Chart!$C$13,Chart!$C$22,Chart!$C$31)</c:f>
                <c:numCache>
                  <c:formatCode>General</c:formatCode>
                  <c:ptCount val="4"/>
                  <c:pt idx="0">
                    <c:v>3.8638238752639356</c:v>
                  </c:pt>
                  <c:pt idx="1">
                    <c:v>5.7618501826107762</c:v>
                  </c:pt>
                  <c:pt idx="2">
                    <c:v>1.8170657874065421</c:v>
                  </c:pt>
                  <c:pt idx="3">
                    <c:v>0.50866332837499451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passage 1</c:v>
              </c:pt>
              <c:pt idx="1">
                <c:v> passage 2</c:v>
              </c:pt>
              <c:pt idx="2">
                <c:v> passage 3</c:v>
              </c:pt>
              <c:pt idx="3">
                <c:v> passage 4</c:v>
              </c:pt>
            </c:strLit>
          </c:cat>
          <c:val>
            <c:numRef>
              <c:f>(Chart!$B$4,Chart!$B$13,Chart!$B$22,Chart!$B$31)</c:f>
              <c:numCache>
                <c:formatCode>General</c:formatCode>
                <c:ptCount val="4"/>
                <c:pt idx="0">
                  <c:v>249.64132478888885</c:v>
                </c:pt>
                <c:pt idx="1">
                  <c:v>282.85048766777777</c:v>
                </c:pt>
                <c:pt idx="2">
                  <c:v>133.00854888444442</c:v>
                </c:pt>
                <c:pt idx="3">
                  <c:v>26.5906566644444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620-3B43-8342-BBAF59AB431B}"/>
            </c:ext>
          </c:extLst>
        </c:ser>
        <c:ser>
          <c:idx val="2"/>
          <c:order val="2"/>
          <c:tx>
            <c:v>T2_A</c:v>
          </c:tx>
          <c:spPr>
            <a:ln w="22225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accent3"/>
              </a:solidFill>
              <a:ln w="3175">
                <a:solidFill>
                  <a:schemeClr val="accent3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hart!$D$5,Chart!$D$14,Chart!$D$23,Chart!$D$32)</c:f>
                <c:numCache>
                  <c:formatCode>General</c:formatCode>
                  <c:ptCount val="4"/>
                  <c:pt idx="0">
                    <c:v>0.57753717297206675</c:v>
                  </c:pt>
                  <c:pt idx="1">
                    <c:v>0.74645563231819256</c:v>
                  </c:pt>
                  <c:pt idx="2">
                    <c:v>0.12658439564832222</c:v>
                  </c:pt>
                  <c:pt idx="3">
                    <c:v>5.4598833179040449E-2</c:v>
                  </c:pt>
                </c:numCache>
              </c:numRef>
            </c:plus>
            <c:minus>
              <c:numRef>
                <c:f>(Chart!$D$5,Chart!$D$14,Chart!$D$23,Chart!$D$32)</c:f>
                <c:numCache>
                  <c:formatCode>General</c:formatCode>
                  <c:ptCount val="4"/>
                  <c:pt idx="0">
                    <c:v>0.57753717297206675</c:v>
                  </c:pt>
                  <c:pt idx="1">
                    <c:v>0.74645563231819256</c:v>
                  </c:pt>
                  <c:pt idx="2">
                    <c:v>0.12658439564832222</c:v>
                  </c:pt>
                  <c:pt idx="3">
                    <c:v>5.4598833179040449E-2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passage 1</c:v>
              </c:pt>
              <c:pt idx="1">
                <c:v> passage 2</c:v>
              </c:pt>
              <c:pt idx="2">
                <c:v> passage 3</c:v>
              </c:pt>
              <c:pt idx="3">
                <c:v> passage 4</c:v>
              </c:pt>
            </c:strLit>
          </c:cat>
          <c:val>
            <c:numRef>
              <c:f>(Chart!$B$5,Chart!$B$14,Chart!$B$23,Chart!$B$32)</c:f>
              <c:numCache>
                <c:formatCode>General</c:formatCode>
                <c:ptCount val="4"/>
                <c:pt idx="0">
                  <c:v>258.60690212222221</c:v>
                </c:pt>
                <c:pt idx="1">
                  <c:v>255.21130222333329</c:v>
                </c:pt>
                <c:pt idx="2">
                  <c:v>62.887639217777775</c:v>
                </c:pt>
                <c:pt idx="3">
                  <c:v>11.2654586644444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620-3B43-8342-BBAF59AB431B}"/>
            </c:ext>
          </c:extLst>
        </c:ser>
        <c:ser>
          <c:idx val="3"/>
          <c:order val="3"/>
          <c:tx>
            <c:v>T3_A</c:v>
          </c:tx>
          <c:spPr>
            <a:ln w="22225" cap="rnd">
              <a:solidFill>
                <a:schemeClr val="accent4"/>
              </a:solidFill>
              <a:round/>
            </a:ln>
            <a:effectLst/>
          </c:spPr>
          <c:marker>
            <c:symbol val="x"/>
            <c:size val="6"/>
            <c:spPr>
              <a:noFill/>
              <a:ln w="3175">
                <a:solidFill>
                  <a:schemeClr val="accent4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hart!$C$6,Chart!$C$15,Chart!$C$24,Chart!$C$33)</c:f>
                <c:numCache>
                  <c:formatCode>General</c:formatCode>
                  <c:ptCount val="4"/>
                  <c:pt idx="0">
                    <c:v>3.9159439467229018</c:v>
                  </c:pt>
                  <c:pt idx="1">
                    <c:v>2.2921915939462196</c:v>
                  </c:pt>
                  <c:pt idx="2">
                    <c:v>7.3218672759970671</c:v>
                  </c:pt>
                  <c:pt idx="3">
                    <c:v>2.8104170431492941</c:v>
                  </c:pt>
                </c:numCache>
              </c:numRef>
            </c:plus>
            <c:minus>
              <c:numRef>
                <c:f>(Chart!$C$6,Chart!$C$15,Chart!$C$24,Chart!$C$33)</c:f>
                <c:numCache>
                  <c:formatCode>General</c:formatCode>
                  <c:ptCount val="4"/>
                  <c:pt idx="0">
                    <c:v>3.9159439467229018</c:v>
                  </c:pt>
                  <c:pt idx="1">
                    <c:v>2.2921915939462196</c:v>
                  </c:pt>
                  <c:pt idx="2">
                    <c:v>7.3218672759970671</c:v>
                  </c:pt>
                  <c:pt idx="3">
                    <c:v>2.8104170431492941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passage 1</c:v>
              </c:pt>
              <c:pt idx="1">
                <c:v> passage 2</c:v>
              </c:pt>
              <c:pt idx="2">
                <c:v> passage 3</c:v>
              </c:pt>
              <c:pt idx="3">
                <c:v> passage 4</c:v>
              </c:pt>
            </c:strLit>
          </c:cat>
          <c:val>
            <c:numRef>
              <c:f>(Chart!$B$6,Chart!$B$15,Chart!$B$24,Chart!$B$33)</c:f>
              <c:numCache>
                <c:formatCode>General</c:formatCode>
                <c:ptCount val="4"/>
                <c:pt idx="0">
                  <c:v>273.47198956666665</c:v>
                </c:pt>
                <c:pt idx="1">
                  <c:v>297.31950811222225</c:v>
                </c:pt>
                <c:pt idx="2">
                  <c:v>195.11126988444443</c:v>
                </c:pt>
                <c:pt idx="3">
                  <c:v>43.4271727755555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620-3B43-8342-BBAF59AB431B}"/>
            </c:ext>
          </c:extLst>
        </c:ser>
        <c:ser>
          <c:idx val="4"/>
          <c:order val="4"/>
          <c:tx>
            <c:v>CON_A</c:v>
          </c:tx>
          <c:spPr>
            <a:ln w="22225" cap="rnd">
              <a:solidFill>
                <a:schemeClr val="accent5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3175">
                <a:solidFill>
                  <a:schemeClr val="accent5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hart!$C$7,Chart!$C$16,Chart!$C$25,Chart!$C$34)</c:f>
                <c:numCache>
                  <c:formatCode>General</c:formatCode>
                  <c:ptCount val="4"/>
                  <c:pt idx="0">
                    <c:v>7.667494175468855</c:v>
                  </c:pt>
                  <c:pt idx="1">
                    <c:v>8.0539889863006771</c:v>
                  </c:pt>
                  <c:pt idx="2">
                    <c:v>4.8050997654348384</c:v>
                  </c:pt>
                  <c:pt idx="3">
                    <c:v>1.605093485698222</c:v>
                  </c:pt>
                </c:numCache>
              </c:numRef>
            </c:plus>
            <c:minus>
              <c:numRef>
                <c:f>(Chart!$C$7,Chart!$C$16,Chart!$C$25,Chart!$C$34)</c:f>
                <c:numCache>
                  <c:formatCode>General</c:formatCode>
                  <c:ptCount val="4"/>
                  <c:pt idx="0">
                    <c:v>7.667494175468855</c:v>
                  </c:pt>
                  <c:pt idx="1">
                    <c:v>8.0539889863006771</c:v>
                  </c:pt>
                  <c:pt idx="2">
                    <c:v>4.8050997654348384</c:v>
                  </c:pt>
                  <c:pt idx="3">
                    <c:v>1.605093485698222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passage 1</c:v>
              </c:pt>
              <c:pt idx="1">
                <c:v> passage 2</c:v>
              </c:pt>
              <c:pt idx="2">
                <c:v> passage 3</c:v>
              </c:pt>
              <c:pt idx="3">
                <c:v> passage 4</c:v>
              </c:pt>
            </c:strLit>
          </c:cat>
          <c:val>
            <c:numRef>
              <c:f>(Chart!$B$7,Chart!$B$16,Chart!$B$25,Chart!$B$34)</c:f>
              <c:numCache>
                <c:formatCode>General</c:formatCode>
                <c:ptCount val="4"/>
                <c:pt idx="0">
                  <c:v>257.46146201111111</c:v>
                </c:pt>
                <c:pt idx="1">
                  <c:v>291.22498355666659</c:v>
                </c:pt>
                <c:pt idx="2">
                  <c:v>252.86253443999996</c:v>
                </c:pt>
                <c:pt idx="3">
                  <c:v>173.7782681088888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620-3B43-8342-BBAF59AB431B}"/>
            </c:ext>
          </c:extLst>
        </c:ser>
        <c:ser>
          <c:idx val="5"/>
          <c:order val="5"/>
          <c:tx>
            <c:v>GGT</c:v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6"/>
              </a:solidFill>
              <a:ln w="3175">
                <a:solidFill>
                  <a:schemeClr val="accent6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hart!$C$8,Chart!$C$17,Chart!$C$26,Chart!$C$35)</c:f>
                <c:numCache>
                  <c:formatCode>General</c:formatCode>
                  <c:ptCount val="4"/>
                  <c:pt idx="0">
                    <c:v>1.8888583677848245</c:v>
                  </c:pt>
                  <c:pt idx="1">
                    <c:v>1.5027080374687281</c:v>
                  </c:pt>
                  <c:pt idx="2">
                    <c:v>1.0844177474886343</c:v>
                  </c:pt>
                  <c:pt idx="3">
                    <c:v>3.7982570100675761</c:v>
                  </c:pt>
                </c:numCache>
              </c:numRef>
            </c:plus>
            <c:minus>
              <c:numRef>
                <c:f>(Chart!$C$8,Chart!$C$17,Chart!$C$26,Chart!$C$35)</c:f>
                <c:numCache>
                  <c:formatCode>General</c:formatCode>
                  <c:ptCount val="4"/>
                  <c:pt idx="0">
                    <c:v>1.8888583677848245</c:v>
                  </c:pt>
                  <c:pt idx="1">
                    <c:v>1.5027080374687281</c:v>
                  </c:pt>
                  <c:pt idx="2">
                    <c:v>1.0844177474886343</c:v>
                  </c:pt>
                  <c:pt idx="3">
                    <c:v>3.7982570100675761</c:v>
                  </c:pt>
                </c:numCache>
              </c:numRef>
            </c:minus>
            <c:spPr>
              <a:noFill/>
              <a:ln w="12700">
                <a:solidFill>
                  <a:schemeClr val="tx1"/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passage 1</c:v>
              </c:pt>
              <c:pt idx="1">
                <c:v> passage 2</c:v>
              </c:pt>
              <c:pt idx="2">
                <c:v> passage 3</c:v>
              </c:pt>
              <c:pt idx="3">
                <c:v> passage 4</c:v>
              </c:pt>
            </c:strLit>
          </c:cat>
          <c:val>
            <c:numRef>
              <c:f>(Chart!$B$8,Chart!$B$17,Chart!$B$26,Chart!$B$35)</c:f>
              <c:numCache>
                <c:formatCode>General</c:formatCode>
                <c:ptCount val="4"/>
                <c:pt idx="0">
                  <c:v>124.90541656666667</c:v>
                </c:pt>
                <c:pt idx="1">
                  <c:v>130.42338177888891</c:v>
                </c:pt>
                <c:pt idx="2">
                  <c:v>128.59873355111111</c:v>
                </c:pt>
                <c:pt idx="3">
                  <c:v>107.975388886666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E620-3B43-8342-BBAF59AB43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917661856"/>
        <c:axId val="-1917650432"/>
      </c:lineChart>
      <c:catAx>
        <c:axId val="-1917661856"/>
        <c:scaling>
          <c:orientation val="minMax"/>
        </c:scaling>
        <c:delete val="0"/>
        <c:axPos val="b"/>
        <c:majorGridlines>
          <c:spPr>
            <a:ln w="1270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0" i="0" u="none" strike="noStrike" kern="1200" cap="all" spc="120" normalizeH="0" baseline="0">
                <a:noFill/>
                <a:latin typeface="Lucida Sans Typewriter" panose="020B0509030504030204" pitchFamily="49" charset="77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917650432"/>
        <c:crosses val="autoZero"/>
        <c:auto val="1"/>
        <c:lblAlgn val="ctr"/>
        <c:lblOffset val="100"/>
        <c:noMultiLvlLbl val="0"/>
      </c:catAx>
      <c:valAx>
        <c:axId val="-1917650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917661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758680555555554"/>
          <c:y val="3.753390201224846E-2"/>
          <c:w val="0.12984375000000001"/>
          <c:h val="0.786043307086614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v>FL_A</c:v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rift_OD600!$I$9:$I$12</c:f>
                <c:numCache>
                  <c:formatCode>General</c:formatCode>
                  <c:ptCount val="4"/>
                  <c:pt idx="0">
                    <c:v>2.0816659994661382E-2</c:v>
                  </c:pt>
                  <c:pt idx="1">
                    <c:v>1.0000000000000231E-2</c:v>
                  </c:pt>
                  <c:pt idx="2">
                    <c:v>6.2449979983984001E-2</c:v>
                  </c:pt>
                  <c:pt idx="3">
                    <c:v>7.8102496759066678E-2</c:v>
                  </c:pt>
                </c:numCache>
              </c:numRef>
            </c:plus>
            <c:minus>
              <c:numRef>
                <c:f>Drift_OD600!$I$9:$I$12</c:f>
                <c:numCache>
                  <c:formatCode>General</c:formatCode>
                  <c:ptCount val="4"/>
                  <c:pt idx="0">
                    <c:v>2.0816659994661382E-2</c:v>
                  </c:pt>
                  <c:pt idx="1">
                    <c:v>1.0000000000000231E-2</c:v>
                  </c:pt>
                  <c:pt idx="2">
                    <c:v>6.2449979983984001E-2</c:v>
                  </c:pt>
                  <c:pt idx="3">
                    <c:v>7.810249675906667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rift_OD600!$I$2:$I$5</c:f>
              <c:numCache>
                <c:formatCode>General</c:formatCode>
                <c:ptCount val="4"/>
                <c:pt idx="0">
                  <c:v>3.4033333333333338</c:v>
                </c:pt>
                <c:pt idx="1">
                  <c:v>3.4899999999999998</c:v>
                </c:pt>
                <c:pt idx="2">
                  <c:v>3.4</c:v>
                </c:pt>
                <c:pt idx="3">
                  <c:v>3.3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E5A-954E-99A5-BAE51A2D0F1E}"/>
            </c:ext>
          </c:extLst>
        </c:ser>
        <c:ser>
          <c:idx val="1"/>
          <c:order val="1"/>
          <c:tx>
            <c:v>T1_A</c:v>
          </c:tx>
          <c:spPr>
            <a:ln w="22225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rift_OD600!$J$9:$J$12</c:f>
                <c:numCache>
                  <c:formatCode>General</c:formatCode>
                  <c:ptCount val="4"/>
                  <c:pt idx="0">
                    <c:v>9.073771725877465E-2</c:v>
                  </c:pt>
                  <c:pt idx="1">
                    <c:v>1.5275252316519577E-2</c:v>
                  </c:pt>
                  <c:pt idx="2">
                    <c:v>3.0550504633038961E-2</c:v>
                  </c:pt>
                  <c:pt idx="3">
                    <c:v>9.1651513899116688E-2</c:v>
                  </c:pt>
                </c:numCache>
              </c:numRef>
            </c:plus>
            <c:minus>
              <c:numRef>
                <c:f>Drift_OD600!$J$9:$J$12</c:f>
                <c:numCache>
                  <c:formatCode>General</c:formatCode>
                  <c:ptCount val="4"/>
                  <c:pt idx="0">
                    <c:v>9.073771725877465E-2</c:v>
                  </c:pt>
                  <c:pt idx="1">
                    <c:v>1.5275252316519577E-2</c:v>
                  </c:pt>
                  <c:pt idx="2">
                    <c:v>3.0550504633038961E-2</c:v>
                  </c:pt>
                  <c:pt idx="3">
                    <c:v>9.165151389911668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rift_OD600!$J$2:$J$5</c:f>
              <c:numCache>
                <c:formatCode>General</c:formatCode>
                <c:ptCount val="4"/>
                <c:pt idx="0">
                  <c:v>2.8966666666666665</c:v>
                </c:pt>
                <c:pt idx="1">
                  <c:v>3.2033333333333336</c:v>
                </c:pt>
                <c:pt idx="2">
                  <c:v>3.1533333333333338</c:v>
                </c:pt>
                <c:pt idx="3">
                  <c:v>3.179999999999999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E5A-954E-99A5-BAE51A2D0F1E}"/>
            </c:ext>
          </c:extLst>
        </c:ser>
        <c:ser>
          <c:idx val="2"/>
          <c:order val="2"/>
          <c:tx>
            <c:v>T2_A</c:v>
          </c:tx>
          <c:spPr>
            <a:ln w="22225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rift_OD600!$K$9:$K$12</c:f>
                <c:numCache>
                  <c:formatCode>General</c:formatCode>
                  <c:ptCount val="4"/>
                  <c:pt idx="0">
                    <c:v>8.9628864398325028E-2</c:v>
                  </c:pt>
                  <c:pt idx="1">
                    <c:v>6.0827625302982323E-2</c:v>
                  </c:pt>
                  <c:pt idx="2">
                    <c:v>3.2145502536643007E-2</c:v>
                  </c:pt>
                  <c:pt idx="3">
                    <c:v>0.11532562594670795</c:v>
                  </c:pt>
                </c:numCache>
              </c:numRef>
            </c:plus>
            <c:minus>
              <c:numRef>
                <c:f>Drift_OD600!$K$9:$K$12</c:f>
                <c:numCache>
                  <c:formatCode>General</c:formatCode>
                  <c:ptCount val="4"/>
                  <c:pt idx="0">
                    <c:v>8.9628864398325028E-2</c:v>
                  </c:pt>
                  <c:pt idx="1">
                    <c:v>6.0827625302982323E-2</c:v>
                  </c:pt>
                  <c:pt idx="2">
                    <c:v>3.2145502536643007E-2</c:v>
                  </c:pt>
                  <c:pt idx="3">
                    <c:v>0.1153256259467079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rift_OD600!$K$2:$K$5</c:f>
              <c:numCache>
                <c:formatCode>General</c:formatCode>
                <c:ptCount val="4"/>
                <c:pt idx="0">
                  <c:v>2.8133333333333339</c:v>
                </c:pt>
                <c:pt idx="1">
                  <c:v>3.24</c:v>
                </c:pt>
                <c:pt idx="2">
                  <c:v>3.2766666666666668</c:v>
                </c:pt>
                <c:pt idx="3">
                  <c:v>3.2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E5A-954E-99A5-BAE51A2D0F1E}"/>
            </c:ext>
          </c:extLst>
        </c:ser>
        <c:ser>
          <c:idx val="3"/>
          <c:order val="3"/>
          <c:tx>
            <c:v>T3_A</c:v>
          </c:tx>
          <c:spPr>
            <a:ln w="22225" cap="rnd">
              <a:solidFill>
                <a:schemeClr val="accent4"/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rift_OD600!$L$9:$L$12</c:f>
                <c:numCache>
                  <c:formatCode>General</c:formatCode>
                  <c:ptCount val="4"/>
                  <c:pt idx="0">
                    <c:v>4.5092497528228866E-2</c:v>
                  </c:pt>
                  <c:pt idx="1">
                    <c:v>8.3864970836060829E-2</c:v>
                  </c:pt>
                  <c:pt idx="2">
                    <c:v>4.7258156262526003E-2</c:v>
                  </c:pt>
                  <c:pt idx="3">
                    <c:v>2.3094010767584792E-2</c:v>
                  </c:pt>
                </c:numCache>
              </c:numRef>
            </c:plus>
            <c:minus>
              <c:numRef>
                <c:f>Drift_OD600!$L$9:$L$12</c:f>
                <c:numCache>
                  <c:formatCode>General</c:formatCode>
                  <c:ptCount val="4"/>
                  <c:pt idx="0">
                    <c:v>4.5092497528228866E-2</c:v>
                  </c:pt>
                  <c:pt idx="1">
                    <c:v>8.3864970836060829E-2</c:v>
                  </c:pt>
                  <c:pt idx="2">
                    <c:v>4.7258156262526003E-2</c:v>
                  </c:pt>
                  <c:pt idx="3">
                    <c:v>2.30940107675847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rift_OD600!$L$2:$L$5</c:f>
              <c:numCache>
                <c:formatCode>General</c:formatCode>
                <c:ptCount val="4"/>
                <c:pt idx="0">
                  <c:v>2.9833333333333329</c:v>
                </c:pt>
                <c:pt idx="1">
                  <c:v>3.2533333333333339</c:v>
                </c:pt>
                <c:pt idx="2">
                  <c:v>3.1766666666666672</c:v>
                </c:pt>
                <c:pt idx="3">
                  <c:v>3.23333333333333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1E5A-954E-99A5-BAE51A2D0F1E}"/>
            </c:ext>
          </c:extLst>
        </c:ser>
        <c:ser>
          <c:idx val="4"/>
          <c:order val="4"/>
          <c:tx>
            <c:v>CON_A</c:v>
          </c:tx>
          <c:spPr>
            <a:ln w="22225" cap="rnd">
              <a:solidFill>
                <a:schemeClr val="accent5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rift_OD600!$M$9:$M$12</c:f>
                <c:numCache>
                  <c:formatCode>General</c:formatCode>
                  <c:ptCount val="4"/>
                  <c:pt idx="0">
                    <c:v>5.131601439446886E-2</c:v>
                  </c:pt>
                  <c:pt idx="1">
                    <c:v>6.6583281184793869E-2</c:v>
                  </c:pt>
                  <c:pt idx="2">
                    <c:v>5.773502691896263E-2</c:v>
                  </c:pt>
                  <c:pt idx="3">
                    <c:v>7.211102550927985E-2</c:v>
                  </c:pt>
                </c:numCache>
              </c:numRef>
            </c:plus>
            <c:minus>
              <c:numRef>
                <c:f>Drift_OD600!$M$9:$M$12</c:f>
                <c:numCache>
                  <c:formatCode>General</c:formatCode>
                  <c:ptCount val="4"/>
                  <c:pt idx="0">
                    <c:v>5.131601439446886E-2</c:v>
                  </c:pt>
                  <c:pt idx="1">
                    <c:v>6.6583281184793869E-2</c:v>
                  </c:pt>
                  <c:pt idx="2">
                    <c:v>5.773502691896263E-2</c:v>
                  </c:pt>
                  <c:pt idx="3">
                    <c:v>7.211102550927985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rift_OD600!$M$2:$M$5</c:f>
              <c:numCache>
                <c:formatCode>General</c:formatCode>
                <c:ptCount val="4"/>
                <c:pt idx="0">
                  <c:v>3.0533333333333332</c:v>
                </c:pt>
                <c:pt idx="1">
                  <c:v>3.3366666666666673</c:v>
                </c:pt>
                <c:pt idx="2">
                  <c:v>3.2433333333333336</c:v>
                </c:pt>
                <c:pt idx="3">
                  <c:v>3.2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1E5A-954E-99A5-BAE51A2D0F1E}"/>
            </c:ext>
          </c:extLst>
        </c:ser>
        <c:ser>
          <c:idx val="5"/>
          <c:order val="5"/>
          <c:tx>
            <c:v>GGT</c:v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rift_OD600!$N$9:$N$12</c:f>
                <c:numCache>
                  <c:formatCode>General</c:formatCode>
                  <c:ptCount val="4"/>
                  <c:pt idx="0">
                    <c:v>6.0277137733416912E-2</c:v>
                  </c:pt>
                  <c:pt idx="1">
                    <c:v>3.2145502536643007E-2</c:v>
                  </c:pt>
                  <c:pt idx="2">
                    <c:v>7.5055534994651521E-2</c:v>
                  </c:pt>
                  <c:pt idx="3">
                    <c:v>3.7859388972001778E-2</c:v>
                  </c:pt>
                </c:numCache>
              </c:numRef>
            </c:plus>
            <c:minus>
              <c:numRef>
                <c:f>Drift_OD600!$N$9:$N$12</c:f>
                <c:numCache>
                  <c:formatCode>General</c:formatCode>
                  <c:ptCount val="4"/>
                  <c:pt idx="0">
                    <c:v>6.0277137733416912E-2</c:v>
                  </c:pt>
                  <c:pt idx="1">
                    <c:v>3.2145502536643007E-2</c:v>
                  </c:pt>
                  <c:pt idx="2">
                    <c:v>7.5055534994651521E-2</c:v>
                  </c:pt>
                  <c:pt idx="3">
                    <c:v>3.785938897200177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Drift_OD600!$N$2:$N$5</c:f>
              <c:numCache>
                <c:formatCode>General</c:formatCode>
                <c:ptCount val="4"/>
                <c:pt idx="0">
                  <c:v>3.4666666666666668</c:v>
                </c:pt>
                <c:pt idx="1">
                  <c:v>3.5233333333333334</c:v>
                </c:pt>
                <c:pt idx="2">
                  <c:v>3.4166666666666665</c:v>
                </c:pt>
                <c:pt idx="3">
                  <c:v>3.473333333333333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1E5A-954E-99A5-BAE51A2D0F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917649888"/>
        <c:axId val="-1917658592"/>
      </c:lineChart>
      <c:catAx>
        <c:axId val="-1917649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917658592"/>
        <c:crosses val="autoZero"/>
        <c:auto val="1"/>
        <c:lblAlgn val="ctr"/>
        <c:lblOffset val="100"/>
        <c:noMultiLvlLbl val="0"/>
      </c:catAx>
      <c:valAx>
        <c:axId val="-1917658592"/>
        <c:scaling>
          <c:orientation val="minMax"/>
          <c:max val="3.7"/>
          <c:min val="2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-1917649888"/>
        <c:crosses val="autoZero"/>
        <c:crossBetween val="between"/>
        <c:majorUnit val="0.30000000000000004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5800347222222217"/>
          <c:y val="6.5311679790026236E-2"/>
          <c:w val="0.12984375000000001"/>
          <c:h val="0.786043307086614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1B728D-8070-CE4E-83EE-E6DBA4E209EF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536575" y="1143000"/>
            <a:ext cx="5784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2BC4D2-2368-D344-9AD3-76E3BF942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28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1pPr>
    <a:lvl2pPr marL="504749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2pPr>
    <a:lvl3pPr marL="1009498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3pPr>
    <a:lvl4pPr marL="1514246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4pPr>
    <a:lvl5pPr marL="2018995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5pPr>
    <a:lvl6pPr marL="2523744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6pPr>
    <a:lvl7pPr marL="3028493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7pPr>
    <a:lvl8pPr marL="3533242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8pPr>
    <a:lvl9pPr marL="4037990" algn="l" defTabSz="1009498" rtl="0" eaLnBrk="1" latinLnBrk="0" hangingPunct="1">
      <a:defRPr sz="132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91CF1A-F801-FB4A-BDC7-5A26AB2B9B4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5056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1197187"/>
            <a:ext cx="10287000" cy="2546773"/>
          </a:xfrm>
        </p:spPr>
        <p:txBody>
          <a:bodyPr anchor="b"/>
          <a:lstStyle>
            <a:lvl1pPr algn="ctr"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3842174"/>
            <a:ext cx="10287000" cy="1766146"/>
          </a:xfrm>
        </p:spPr>
        <p:txBody>
          <a:bodyPr/>
          <a:lstStyle>
            <a:lvl1pPr marL="0" indent="0" algn="ctr">
              <a:buNone/>
              <a:defRPr sz="2560"/>
            </a:lvl1pPr>
            <a:lvl2pPr marL="487695" indent="0" algn="ctr">
              <a:buNone/>
              <a:defRPr sz="2133"/>
            </a:lvl2pPr>
            <a:lvl3pPr marL="975390" indent="0" algn="ctr">
              <a:buNone/>
              <a:defRPr sz="1920"/>
            </a:lvl3pPr>
            <a:lvl4pPr marL="1463086" indent="0" algn="ctr">
              <a:buNone/>
              <a:defRPr sz="1707"/>
            </a:lvl4pPr>
            <a:lvl5pPr marL="1950781" indent="0" algn="ctr">
              <a:buNone/>
              <a:defRPr sz="1707"/>
            </a:lvl5pPr>
            <a:lvl6pPr marL="2438476" indent="0" algn="ctr">
              <a:buNone/>
              <a:defRPr sz="1707"/>
            </a:lvl6pPr>
            <a:lvl7pPr marL="2926171" indent="0" algn="ctr">
              <a:buNone/>
              <a:defRPr sz="1707"/>
            </a:lvl7pPr>
            <a:lvl8pPr marL="3413867" indent="0" algn="ctr">
              <a:buNone/>
              <a:defRPr sz="1707"/>
            </a:lvl8pPr>
            <a:lvl9pPr marL="3901562" indent="0" algn="ctr">
              <a:buNone/>
              <a:defRPr sz="170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535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559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2" y="389467"/>
            <a:ext cx="2957513" cy="61992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5" y="389467"/>
            <a:ext cx="8701088" cy="619929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555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481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1" y="1823721"/>
            <a:ext cx="11830050" cy="3042919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1" y="4895428"/>
            <a:ext cx="11830050" cy="1600199"/>
          </a:xfrm>
        </p:spPr>
        <p:txBody>
          <a:bodyPr/>
          <a:lstStyle>
            <a:lvl1pPr marL="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1pPr>
            <a:lvl2pPr marL="487695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2pPr>
            <a:lvl3pPr marL="97539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3pPr>
            <a:lvl4pPr marL="1463086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4pPr>
            <a:lvl5pPr marL="1950781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5pPr>
            <a:lvl6pPr marL="2438476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6pPr>
            <a:lvl7pPr marL="2926171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7pPr>
            <a:lvl8pPr marL="3413867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8pPr>
            <a:lvl9pPr marL="3901562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719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1947333"/>
            <a:ext cx="5829300" cy="4641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1947333"/>
            <a:ext cx="5829300" cy="46414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800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389467"/>
            <a:ext cx="11830050" cy="14139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2" y="1793241"/>
            <a:ext cx="5802510" cy="878839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695" indent="0">
              <a:buNone/>
              <a:defRPr sz="2133" b="1"/>
            </a:lvl2pPr>
            <a:lvl3pPr marL="975390" indent="0">
              <a:buNone/>
              <a:defRPr sz="1920" b="1"/>
            </a:lvl3pPr>
            <a:lvl4pPr marL="1463086" indent="0">
              <a:buNone/>
              <a:defRPr sz="1707" b="1"/>
            </a:lvl4pPr>
            <a:lvl5pPr marL="1950781" indent="0">
              <a:buNone/>
              <a:defRPr sz="1707" b="1"/>
            </a:lvl5pPr>
            <a:lvl6pPr marL="2438476" indent="0">
              <a:buNone/>
              <a:defRPr sz="1707" b="1"/>
            </a:lvl6pPr>
            <a:lvl7pPr marL="2926171" indent="0">
              <a:buNone/>
              <a:defRPr sz="1707" b="1"/>
            </a:lvl7pPr>
            <a:lvl8pPr marL="3413867" indent="0">
              <a:buNone/>
              <a:defRPr sz="1707" b="1"/>
            </a:lvl8pPr>
            <a:lvl9pPr marL="3901562" indent="0">
              <a:buNone/>
              <a:defRPr sz="17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2" y="2672080"/>
            <a:ext cx="5802510" cy="39302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5" y="1793241"/>
            <a:ext cx="5831087" cy="878839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695" indent="0">
              <a:buNone/>
              <a:defRPr sz="2133" b="1"/>
            </a:lvl2pPr>
            <a:lvl3pPr marL="975390" indent="0">
              <a:buNone/>
              <a:defRPr sz="1920" b="1"/>
            </a:lvl3pPr>
            <a:lvl4pPr marL="1463086" indent="0">
              <a:buNone/>
              <a:defRPr sz="1707" b="1"/>
            </a:lvl4pPr>
            <a:lvl5pPr marL="1950781" indent="0">
              <a:buNone/>
              <a:defRPr sz="1707" b="1"/>
            </a:lvl5pPr>
            <a:lvl6pPr marL="2438476" indent="0">
              <a:buNone/>
              <a:defRPr sz="1707" b="1"/>
            </a:lvl6pPr>
            <a:lvl7pPr marL="2926171" indent="0">
              <a:buNone/>
              <a:defRPr sz="1707" b="1"/>
            </a:lvl7pPr>
            <a:lvl8pPr marL="3413867" indent="0">
              <a:buNone/>
              <a:defRPr sz="1707" b="1"/>
            </a:lvl8pPr>
            <a:lvl9pPr marL="3901562" indent="0">
              <a:buNone/>
              <a:defRPr sz="17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5" y="2672080"/>
            <a:ext cx="5831087" cy="393022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96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431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1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87680"/>
            <a:ext cx="4423767" cy="1706880"/>
          </a:xfrm>
        </p:spPr>
        <p:txBody>
          <a:bodyPr anchor="b"/>
          <a:lstStyle>
            <a:lvl1pPr>
              <a:defRPr sz="34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053254"/>
            <a:ext cx="6943725" cy="5198533"/>
          </a:xfrm>
        </p:spPr>
        <p:txBody>
          <a:bodyPr/>
          <a:lstStyle>
            <a:lvl1pPr>
              <a:defRPr sz="3413"/>
            </a:lvl1pPr>
            <a:lvl2pPr>
              <a:defRPr sz="2987"/>
            </a:lvl2pPr>
            <a:lvl3pPr>
              <a:defRPr sz="256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2194560"/>
            <a:ext cx="4423767" cy="4065694"/>
          </a:xfrm>
        </p:spPr>
        <p:txBody>
          <a:bodyPr/>
          <a:lstStyle>
            <a:lvl1pPr marL="0" indent="0">
              <a:buNone/>
              <a:defRPr sz="1707"/>
            </a:lvl1pPr>
            <a:lvl2pPr marL="487695" indent="0">
              <a:buNone/>
              <a:defRPr sz="1493"/>
            </a:lvl2pPr>
            <a:lvl3pPr marL="975390" indent="0">
              <a:buNone/>
              <a:defRPr sz="1280"/>
            </a:lvl3pPr>
            <a:lvl4pPr marL="1463086" indent="0">
              <a:buNone/>
              <a:defRPr sz="1067"/>
            </a:lvl4pPr>
            <a:lvl5pPr marL="1950781" indent="0">
              <a:buNone/>
              <a:defRPr sz="1067"/>
            </a:lvl5pPr>
            <a:lvl6pPr marL="2438476" indent="0">
              <a:buNone/>
              <a:defRPr sz="1067"/>
            </a:lvl6pPr>
            <a:lvl7pPr marL="2926171" indent="0">
              <a:buNone/>
              <a:defRPr sz="1067"/>
            </a:lvl7pPr>
            <a:lvl8pPr marL="3413867" indent="0">
              <a:buNone/>
              <a:defRPr sz="1067"/>
            </a:lvl8pPr>
            <a:lvl9pPr marL="3901562" indent="0">
              <a:buNone/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069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487680"/>
            <a:ext cx="4423767" cy="1706880"/>
          </a:xfrm>
        </p:spPr>
        <p:txBody>
          <a:bodyPr anchor="b"/>
          <a:lstStyle>
            <a:lvl1pPr>
              <a:defRPr sz="34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053254"/>
            <a:ext cx="6943725" cy="5198533"/>
          </a:xfrm>
        </p:spPr>
        <p:txBody>
          <a:bodyPr anchor="t"/>
          <a:lstStyle>
            <a:lvl1pPr marL="0" indent="0">
              <a:buNone/>
              <a:defRPr sz="3413"/>
            </a:lvl1pPr>
            <a:lvl2pPr marL="487695" indent="0">
              <a:buNone/>
              <a:defRPr sz="2987"/>
            </a:lvl2pPr>
            <a:lvl3pPr marL="975390" indent="0">
              <a:buNone/>
              <a:defRPr sz="2560"/>
            </a:lvl3pPr>
            <a:lvl4pPr marL="1463086" indent="0">
              <a:buNone/>
              <a:defRPr sz="2133"/>
            </a:lvl4pPr>
            <a:lvl5pPr marL="1950781" indent="0">
              <a:buNone/>
              <a:defRPr sz="2133"/>
            </a:lvl5pPr>
            <a:lvl6pPr marL="2438476" indent="0">
              <a:buNone/>
              <a:defRPr sz="2133"/>
            </a:lvl6pPr>
            <a:lvl7pPr marL="2926171" indent="0">
              <a:buNone/>
              <a:defRPr sz="2133"/>
            </a:lvl7pPr>
            <a:lvl8pPr marL="3413867" indent="0">
              <a:buNone/>
              <a:defRPr sz="2133"/>
            </a:lvl8pPr>
            <a:lvl9pPr marL="3901562" indent="0">
              <a:buNone/>
              <a:defRPr sz="21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2194560"/>
            <a:ext cx="4423767" cy="4065694"/>
          </a:xfrm>
        </p:spPr>
        <p:txBody>
          <a:bodyPr/>
          <a:lstStyle>
            <a:lvl1pPr marL="0" indent="0">
              <a:buNone/>
              <a:defRPr sz="1707"/>
            </a:lvl1pPr>
            <a:lvl2pPr marL="487695" indent="0">
              <a:buNone/>
              <a:defRPr sz="1493"/>
            </a:lvl2pPr>
            <a:lvl3pPr marL="975390" indent="0">
              <a:buNone/>
              <a:defRPr sz="1280"/>
            </a:lvl3pPr>
            <a:lvl4pPr marL="1463086" indent="0">
              <a:buNone/>
              <a:defRPr sz="1067"/>
            </a:lvl4pPr>
            <a:lvl5pPr marL="1950781" indent="0">
              <a:buNone/>
              <a:defRPr sz="1067"/>
            </a:lvl5pPr>
            <a:lvl6pPr marL="2438476" indent="0">
              <a:buNone/>
              <a:defRPr sz="1067"/>
            </a:lvl6pPr>
            <a:lvl7pPr marL="2926171" indent="0">
              <a:buNone/>
              <a:defRPr sz="1067"/>
            </a:lvl7pPr>
            <a:lvl8pPr marL="3413867" indent="0">
              <a:buNone/>
              <a:defRPr sz="1067"/>
            </a:lvl8pPr>
            <a:lvl9pPr marL="3901562" indent="0">
              <a:buNone/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876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389467"/>
            <a:ext cx="1183005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1947333"/>
            <a:ext cx="1183005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6780107"/>
            <a:ext cx="30861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5DCAF-4F81-1D45-96D7-DE97DF75CE4C}" type="datetimeFigureOut">
              <a:rPr lang="en-US" smtClean="0"/>
              <a:t>10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6780107"/>
            <a:ext cx="462915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6780107"/>
            <a:ext cx="30861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F6353-8264-E344-8426-A504558532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95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75390" rtl="0" eaLnBrk="1" latinLnBrk="0" hangingPunct="1">
        <a:lnSpc>
          <a:spcPct val="90000"/>
        </a:lnSpc>
        <a:spcBef>
          <a:spcPct val="0"/>
        </a:spcBef>
        <a:buNone/>
        <a:defRPr sz="469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848" indent="-243848" algn="l" defTabSz="9753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2987" kern="1200">
          <a:solidFill>
            <a:schemeClr val="tx1"/>
          </a:solidFill>
          <a:latin typeface="+mn-lt"/>
          <a:ea typeface="+mn-ea"/>
          <a:cs typeface="+mn-cs"/>
        </a:defRPr>
      </a:lvl1pPr>
      <a:lvl2pPr marL="731543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38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3pPr>
      <a:lvl4pPr marL="1706933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2194629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682324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3170019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657714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4145410" indent="-243848" algn="l" defTabSz="97539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695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5390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3086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50781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8476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6171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13867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901562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5" Type="http://schemas.openxmlformats.org/officeDocument/2006/relationships/chart" Target="../charts/chart1.xml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A picture containing fabric&#10;&#10;Description automatically generated">
            <a:extLst>
              <a:ext uri="{FF2B5EF4-FFF2-40B4-BE49-F238E27FC236}">
                <a16:creationId xmlns:a16="http://schemas.microsoft.com/office/drawing/2014/main" xmlns="" id="{B21FBD40-641B-1349-96B1-C3777046D1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1944" y="4398651"/>
            <a:ext cx="1280160" cy="1280160"/>
          </a:xfrm>
          <a:prstGeom prst="rect">
            <a:avLst/>
          </a:prstGeom>
        </p:spPr>
      </p:pic>
      <p:pic>
        <p:nvPicPr>
          <p:cNvPr id="68" name="Picture 67" descr="A picture containing night sky&#10;&#10;Description automatically generated">
            <a:extLst>
              <a:ext uri="{FF2B5EF4-FFF2-40B4-BE49-F238E27FC236}">
                <a16:creationId xmlns:a16="http://schemas.microsoft.com/office/drawing/2014/main" xmlns="" id="{B8E68699-B26E-D641-81D5-3C832EB40D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5697" y="4398648"/>
            <a:ext cx="1280160" cy="1280160"/>
          </a:xfrm>
          <a:prstGeom prst="rect">
            <a:avLst/>
          </a:prstGeom>
        </p:spPr>
      </p:pic>
      <p:pic>
        <p:nvPicPr>
          <p:cNvPr id="70" name="Picture 69" descr="Stars and galaxies in space&#10;&#10;Description automatically generated with medium confidence">
            <a:extLst>
              <a:ext uri="{FF2B5EF4-FFF2-40B4-BE49-F238E27FC236}">
                <a16:creationId xmlns:a16="http://schemas.microsoft.com/office/drawing/2014/main" xmlns="" id="{46FDB7FF-33CE-8F44-B81E-FEBC65FB8F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75889" y="4398648"/>
            <a:ext cx="1280160" cy="1280160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xmlns="" id="{72F52D81-2B7F-E645-9AFB-C15A4B563E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7891" y="4397230"/>
            <a:ext cx="1280160" cy="1280160"/>
          </a:xfrm>
          <a:prstGeom prst="rect">
            <a:avLst/>
          </a:prstGeom>
        </p:spPr>
      </p:pic>
      <p:pic>
        <p:nvPicPr>
          <p:cNvPr id="74" name="Picture 73" descr="A picture containing fabric&#10;&#10;Description automatically generated">
            <a:extLst>
              <a:ext uri="{FF2B5EF4-FFF2-40B4-BE49-F238E27FC236}">
                <a16:creationId xmlns:a16="http://schemas.microsoft.com/office/drawing/2014/main" xmlns="" id="{EEAC3476-CDE5-9C48-B85F-79FAFF6523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00665" y="4397230"/>
            <a:ext cx="1280160" cy="1280160"/>
          </a:xfrm>
          <a:prstGeom prst="rect">
            <a:avLst/>
          </a:prstGeom>
        </p:spPr>
      </p:pic>
      <p:pic>
        <p:nvPicPr>
          <p:cNvPr id="76" name="Picture 75" descr="A picture containing fabric&#10;&#10;Description automatically generated">
            <a:extLst>
              <a:ext uri="{FF2B5EF4-FFF2-40B4-BE49-F238E27FC236}">
                <a16:creationId xmlns:a16="http://schemas.microsoft.com/office/drawing/2014/main" xmlns="" id="{00695B6D-7B4A-5143-895D-CC4F6AD20CF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646622" y="4397230"/>
            <a:ext cx="1280160" cy="1280160"/>
          </a:xfrm>
          <a:prstGeom prst="rect">
            <a:avLst/>
          </a:prstGeom>
        </p:spPr>
      </p:pic>
      <p:pic>
        <p:nvPicPr>
          <p:cNvPr id="11" name="Picture 10" descr="A picture containing indoor, close&#10;&#10;Description automatically generated">
            <a:extLst>
              <a:ext uri="{FF2B5EF4-FFF2-40B4-BE49-F238E27FC236}">
                <a16:creationId xmlns:a16="http://schemas.microsoft.com/office/drawing/2014/main" xmlns="" id="{115BDC94-C20A-3445-A24C-9F6A66AB7D7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92171" y="5735963"/>
            <a:ext cx="1371600" cy="1371600"/>
          </a:xfrm>
          <a:prstGeom prst="rect">
            <a:avLst/>
          </a:prstGeom>
        </p:spPr>
      </p:pic>
      <p:pic>
        <p:nvPicPr>
          <p:cNvPr id="31" name="Picture 30" descr="A picture containing tableware, dishware&#10;&#10;Description automatically generated">
            <a:extLst>
              <a:ext uri="{FF2B5EF4-FFF2-40B4-BE49-F238E27FC236}">
                <a16:creationId xmlns:a16="http://schemas.microsoft.com/office/drawing/2014/main" xmlns="" id="{403B5750-C9D8-A440-9CD1-56C23E4A111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54945" y="5735963"/>
            <a:ext cx="1371600" cy="1371600"/>
          </a:xfrm>
          <a:prstGeom prst="rect">
            <a:avLst/>
          </a:prstGeom>
        </p:spPr>
      </p:pic>
      <p:pic>
        <p:nvPicPr>
          <p:cNvPr id="34" name="Picture 33" descr="A picture containing dishware&#10;&#10;Description automatically generated">
            <a:extLst>
              <a:ext uri="{FF2B5EF4-FFF2-40B4-BE49-F238E27FC236}">
                <a16:creationId xmlns:a16="http://schemas.microsoft.com/office/drawing/2014/main" xmlns="" id="{987C24D7-6057-E24A-AF51-16DE7813558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600902" y="5735963"/>
            <a:ext cx="1371600" cy="1371600"/>
          </a:xfrm>
          <a:prstGeom prst="rect">
            <a:avLst/>
          </a:prstGeom>
        </p:spPr>
      </p:pic>
      <p:pic>
        <p:nvPicPr>
          <p:cNvPr id="9" name="Picture 8" descr="A close-up of a planet&#10;&#10;Description automatically generated with low confidence">
            <a:extLst>
              <a:ext uri="{FF2B5EF4-FFF2-40B4-BE49-F238E27FC236}">
                <a16:creationId xmlns:a16="http://schemas.microsoft.com/office/drawing/2014/main" xmlns="" id="{5B0ABB1A-7FA1-6A40-9164-96D82177912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530169" y="5735963"/>
            <a:ext cx="1371600" cy="1371600"/>
          </a:xfrm>
          <a:prstGeom prst="rect">
            <a:avLst/>
          </a:prstGeom>
        </p:spPr>
      </p:pic>
      <p:pic>
        <p:nvPicPr>
          <p:cNvPr id="4" name="Picture 3" descr="A picture containing indoor, Petri dish, tableware, dishware&#10;&#10;Description automatically generated">
            <a:extLst>
              <a:ext uri="{FF2B5EF4-FFF2-40B4-BE49-F238E27FC236}">
                <a16:creationId xmlns:a16="http://schemas.microsoft.com/office/drawing/2014/main" xmlns="" id="{02B4C33B-44AE-BA4F-8FF0-BFAECF43012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806224" y="5735963"/>
            <a:ext cx="1371600" cy="1371600"/>
          </a:xfrm>
          <a:prstGeom prst="rect">
            <a:avLst/>
          </a:prstGeom>
        </p:spPr>
      </p:pic>
      <p:pic>
        <p:nvPicPr>
          <p:cNvPr id="7" name="Picture 6" descr="A picture containing indoor&#10;&#10;Description automatically generated">
            <a:extLst>
              <a:ext uri="{FF2B5EF4-FFF2-40B4-BE49-F238E27FC236}">
                <a16:creationId xmlns:a16="http://schemas.microsoft.com/office/drawing/2014/main" xmlns="" id="{259298D8-30C8-494F-B1D7-21F8DB65761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69977" y="5735963"/>
            <a:ext cx="1371600" cy="13716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2F13438F-3CC1-F04F-A4C9-1FABD1B4BBC6}"/>
              </a:ext>
            </a:extLst>
          </p:cNvPr>
          <p:cNvSpPr txBox="1"/>
          <p:nvPr/>
        </p:nvSpPr>
        <p:spPr>
          <a:xfrm>
            <a:off x="3200117" y="7079888"/>
            <a:ext cx="58381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FL_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06A2C7E1-05F2-7344-BACD-5C80E8294495}"/>
              </a:ext>
            </a:extLst>
          </p:cNvPr>
          <p:cNvSpPr txBox="1"/>
          <p:nvPr/>
        </p:nvSpPr>
        <p:spPr>
          <a:xfrm>
            <a:off x="4563870" y="7079888"/>
            <a:ext cx="58381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T1_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E8BE8E79-B3B1-1D40-8850-7677A24BFC74}"/>
              </a:ext>
            </a:extLst>
          </p:cNvPr>
          <p:cNvSpPr txBox="1"/>
          <p:nvPr/>
        </p:nvSpPr>
        <p:spPr>
          <a:xfrm>
            <a:off x="5924062" y="7079888"/>
            <a:ext cx="58381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T2_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0612174-548E-4C43-A57D-D1EA79FC1D21}"/>
              </a:ext>
            </a:extLst>
          </p:cNvPr>
          <p:cNvSpPr txBox="1"/>
          <p:nvPr/>
        </p:nvSpPr>
        <p:spPr>
          <a:xfrm>
            <a:off x="7286064" y="7079888"/>
            <a:ext cx="58381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T3_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6177954B-08F7-FE4B-ADD4-65DA55942269}"/>
              </a:ext>
            </a:extLst>
          </p:cNvPr>
          <p:cNvSpPr txBox="1"/>
          <p:nvPr/>
        </p:nvSpPr>
        <p:spPr>
          <a:xfrm>
            <a:off x="8561475" y="7079888"/>
            <a:ext cx="75854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CON_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CE4C1B4B-6781-B441-A4DB-F96B2942CF22}"/>
              </a:ext>
            </a:extLst>
          </p:cNvPr>
          <p:cNvSpPr txBox="1"/>
          <p:nvPr/>
        </p:nvSpPr>
        <p:spPr>
          <a:xfrm>
            <a:off x="10013230" y="7079888"/>
            <a:ext cx="54694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GGT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xmlns="" id="{E89E859B-3358-904A-BAFE-772E5DEFDA5D}"/>
              </a:ext>
            </a:extLst>
          </p:cNvPr>
          <p:cNvCxnSpPr>
            <a:cxnSpLocks/>
          </p:cNvCxnSpPr>
          <p:nvPr/>
        </p:nvCxnSpPr>
        <p:spPr>
          <a:xfrm flipH="1" flipV="1">
            <a:off x="2845731" y="5678811"/>
            <a:ext cx="302790" cy="688361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xmlns="" id="{D8E38127-2590-8242-B929-9F76DE1F7EA3}"/>
              </a:ext>
            </a:extLst>
          </p:cNvPr>
          <p:cNvCxnSpPr>
            <a:cxnSpLocks/>
          </p:cNvCxnSpPr>
          <p:nvPr/>
        </p:nvCxnSpPr>
        <p:spPr>
          <a:xfrm flipV="1">
            <a:off x="3457421" y="5675778"/>
            <a:ext cx="670810" cy="674309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xmlns="" id="{19115594-268B-354F-8240-EFB425D30B4E}"/>
              </a:ext>
            </a:extLst>
          </p:cNvPr>
          <p:cNvSpPr>
            <a:spLocks noChangeAspect="1"/>
          </p:cNvSpPr>
          <p:nvPr/>
        </p:nvSpPr>
        <p:spPr>
          <a:xfrm>
            <a:off x="3149304" y="6367172"/>
            <a:ext cx="292608" cy="292608"/>
          </a:xfrm>
          <a:prstGeom prst="rect">
            <a:avLst/>
          </a:prstGeom>
          <a:noFill/>
          <a:ln w="952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xmlns="" id="{8EE5CDC9-D5E4-8147-8BF3-F3E2BA3E42A2}"/>
              </a:ext>
            </a:extLst>
          </p:cNvPr>
          <p:cNvCxnSpPr>
            <a:cxnSpLocks/>
          </p:cNvCxnSpPr>
          <p:nvPr/>
        </p:nvCxnSpPr>
        <p:spPr>
          <a:xfrm flipH="1" flipV="1">
            <a:off x="4215698" y="5675779"/>
            <a:ext cx="336103" cy="871793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07C44141-9BF7-704C-8D1E-0BF3F95357E5}"/>
              </a:ext>
            </a:extLst>
          </p:cNvPr>
          <p:cNvCxnSpPr>
            <a:cxnSpLocks/>
          </p:cNvCxnSpPr>
          <p:nvPr/>
        </p:nvCxnSpPr>
        <p:spPr>
          <a:xfrm flipV="1">
            <a:off x="4855777" y="5675778"/>
            <a:ext cx="644425" cy="871795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xmlns="" id="{EFD441BF-AE67-6546-8AD4-57FF1CEAF52A}"/>
              </a:ext>
            </a:extLst>
          </p:cNvPr>
          <p:cNvSpPr>
            <a:spLocks noChangeAspect="1"/>
          </p:cNvSpPr>
          <p:nvPr/>
        </p:nvSpPr>
        <p:spPr>
          <a:xfrm>
            <a:off x="4551801" y="6547572"/>
            <a:ext cx="292607" cy="292608"/>
          </a:xfrm>
          <a:prstGeom prst="rect">
            <a:avLst/>
          </a:prstGeom>
          <a:noFill/>
          <a:ln w="952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70E6854A-7BE1-C344-A772-2ACF9DAF0F09}"/>
              </a:ext>
            </a:extLst>
          </p:cNvPr>
          <p:cNvCxnSpPr>
            <a:cxnSpLocks/>
          </p:cNvCxnSpPr>
          <p:nvPr/>
        </p:nvCxnSpPr>
        <p:spPr>
          <a:xfrm flipH="1" flipV="1">
            <a:off x="5576097" y="5675778"/>
            <a:ext cx="184737" cy="508457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xmlns="" id="{073A75F8-5C53-D643-A062-862FE6B408DE}"/>
              </a:ext>
            </a:extLst>
          </p:cNvPr>
          <p:cNvCxnSpPr>
            <a:cxnSpLocks/>
          </p:cNvCxnSpPr>
          <p:nvPr/>
        </p:nvCxnSpPr>
        <p:spPr>
          <a:xfrm flipV="1">
            <a:off x="6053440" y="5675778"/>
            <a:ext cx="798933" cy="508458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xmlns="" id="{9DAE9903-8DC0-A64B-A07A-05E1D6DCEF8D}"/>
              </a:ext>
            </a:extLst>
          </p:cNvPr>
          <p:cNvSpPr>
            <a:spLocks noChangeAspect="1"/>
          </p:cNvSpPr>
          <p:nvPr/>
        </p:nvSpPr>
        <p:spPr>
          <a:xfrm>
            <a:off x="5760833" y="6184235"/>
            <a:ext cx="292607" cy="292608"/>
          </a:xfrm>
          <a:prstGeom prst="rect">
            <a:avLst/>
          </a:prstGeom>
          <a:noFill/>
          <a:ln w="952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xmlns="" id="{1999A9CA-EC0A-C74C-A06C-D0ACE33C0E49}"/>
              </a:ext>
            </a:extLst>
          </p:cNvPr>
          <p:cNvCxnSpPr>
            <a:cxnSpLocks/>
          </p:cNvCxnSpPr>
          <p:nvPr/>
        </p:nvCxnSpPr>
        <p:spPr>
          <a:xfrm flipH="1" flipV="1">
            <a:off x="6934086" y="5664751"/>
            <a:ext cx="270924" cy="685336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4EA2285A-DDA1-B448-88F8-2BE885359411}"/>
              </a:ext>
            </a:extLst>
          </p:cNvPr>
          <p:cNvCxnSpPr>
            <a:cxnSpLocks/>
          </p:cNvCxnSpPr>
          <p:nvPr/>
        </p:nvCxnSpPr>
        <p:spPr>
          <a:xfrm flipV="1">
            <a:off x="7527545" y="5675778"/>
            <a:ext cx="686700" cy="674310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xmlns="" id="{8634C453-870A-B343-9361-9624762B2014}"/>
              </a:ext>
            </a:extLst>
          </p:cNvPr>
          <p:cNvSpPr>
            <a:spLocks noChangeAspect="1"/>
          </p:cNvSpPr>
          <p:nvPr/>
        </p:nvSpPr>
        <p:spPr>
          <a:xfrm>
            <a:off x="7214220" y="6361103"/>
            <a:ext cx="292607" cy="292608"/>
          </a:xfrm>
          <a:prstGeom prst="rect">
            <a:avLst/>
          </a:prstGeom>
          <a:noFill/>
          <a:ln w="952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E281373F-C159-6B4A-A3AA-5516489D1A3C}"/>
              </a:ext>
            </a:extLst>
          </p:cNvPr>
          <p:cNvCxnSpPr>
            <a:cxnSpLocks/>
          </p:cNvCxnSpPr>
          <p:nvPr/>
        </p:nvCxnSpPr>
        <p:spPr>
          <a:xfrm flipH="1" flipV="1">
            <a:off x="8304774" y="5664751"/>
            <a:ext cx="227178" cy="696353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xmlns="" id="{32F696D7-EE93-E940-A4A9-D816854355EE}"/>
              </a:ext>
            </a:extLst>
          </p:cNvPr>
          <p:cNvCxnSpPr>
            <a:cxnSpLocks/>
          </p:cNvCxnSpPr>
          <p:nvPr/>
        </p:nvCxnSpPr>
        <p:spPr>
          <a:xfrm flipV="1">
            <a:off x="8829727" y="5675778"/>
            <a:ext cx="755207" cy="701849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>
            <a:extLst>
              <a:ext uri="{FF2B5EF4-FFF2-40B4-BE49-F238E27FC236}">
                <a16:creationId xmlns:a16="http://schemas.microsoft.com/office/drawing/2014/main" xmlns="" id="{A7542080-15E3-564C-9D5A-145E176AEF74}"/>
              </a:ext>
            </a:extLst>
          </p:cNvPr>
          <p:cNvSpPr>
            <a:spLocks noChangeAspect="1"/>
          </p:cNvSpPr>
          <p:nvPr/>
        </p:nvSpPr>
        <p:spPr>
          <a:xfrm>
            <a:off x="8537120" y="6377627"/>
            <a:ext cx="292607" cy="292608"/>
          </a:xfrm>
          <a:prstGeom prst="rect">
            <a:avLst/>
          </a:prstGeom>
          <a:noFill/>
          <a:ln w="952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xmlns="" id="{B7AE0892-A6D1-D844-92FF-BC8F52CE1C36}"/>
              </a:ext>
            </a:extLst>
          </p:cNvPr>
          <p:cNvCxnSpPr>
            <a:cxnSpLocks/>
          </p:cNvCxnSpPr>
          <p:nvPr/>
        </p:nvCxnSpPr>
        <p:spPr>
          <a:xfrm flipH="1" flipV="1">
            <a:off x="9665174" y="5675778"/>
            <a:ext cx="126965" cy="740473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xmlns="" id="{BF610FCB-6B47-804B-ADC9-69F89E3C37F2}"/>
              </a:ext>
            </a:extLst>
          </p:cNvPr>
          <p:cNvCxnSpPr>
            <a:cxnSpLocks/>
          </p:cNvCxnSpPr>
          <p:nvPr/>
        </p:nvCxnSpPr>
        <p:spPr>
          <a:xfrm flipV="1">
            <a:off x="10084745" y="5683021"/>
            <a:ext cx="859678" cy="733230"/>
          </a:xfrm>
          <a:prstGeom prst="line">
            <a:avLst/>
          </a:prstGeom>
          <a:ln w="9525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xmlns="" id="{A23E38B2-4195-6445-87D8-5D6097512FEE}"/>
              </a:ext>
            </a:extLst>
          </p:cNvPr>
          <p:cNvSpPr>
            <a:spLocks noChangeAspect="1"/>
          </p:cNvSpPr>
          <p:nvPr/>
        </p:nvSpPr>
        <p:spPr>
          <a:xfrm>
            <a:off x="9792138" y="6416250"/>
            <a:ext cx="292607" cy="292608"/>
          </a:xfrm>
          <a:prstGeom prst="rect">
            <a:avLst/>
          </a:prstGeom>
          <a:noFill/>
          <a:ln w="9525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graphicFrame>
        <p:nvGraphicFramePr>
          <p:cNvPr id="40" name="Chart 39">
            <a:extLst>
              <a:ext uri="{FF2B5EF4-FFF2-40B4-BE49-F238E27FC236}">
                <a16:creationId xmlns:a16="http://schemas.microsoft.com/office/drawing/2014/main" xmlns="" id="{92803236-7F3A-AD44-A99B-C4FE6801BB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1952707"/>
              </p:ext>
            </p:extLst>
          </p:nvPr>
        </p:nvGraphicFramePr>
        <p:xfrm>
          <a:off x="3402503" y="188849"/>
          <a:ext cx="7315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03DCB982-ACBE-8C4F-8895-ABBD602FB289}"/>
              </a:ext>
            </a:extLst>
          </p:cNvPr>
          <p:cNvSpPr txBox="1"/>
          <p:nvPr/>
        </p:nvSpPr>
        <p:spPr>
          <a:xfrm rot="16200000">
            <a:off x="3019929" y="747497"/>
            <a:ext cx="518091" cy="29238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  <a:cs typeface="Arial" panose="020B0604020202020204" pitchFamily="34" charset="0"/>
              </a:rPr>
              <a:t>AFU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79A5A170-A227-9A4D-B600-EA2CFF45ADBC}"/>
              </a:ext>
            </a:extLst>
          </p:cNvPr>
          <p:cNvSpPr txBox="1"/>
          <p:nvPr/>
        </p:nvSpPr>
        <p:spPr>
          <a:xfrm>
            <a:off x="4103687" y="1670405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Passage 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155345BF-9A9C-1B48-B30C-4137E20E1DF3}"/>
              </a:ext>
            </a:extLst>
          </p:cNvPr>
          <p:cNvSpPr txBox="1"/>
          <p:nvPr/>
        </p:nvSpPr>
        <p:spPr>
          <a:xfrm>
            <a:off x="5515057" y="1670405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>
                <a:latin typeface="Helvetica" pitchFamily="2" charset="0"/>
              </a:rPr>
              <a:t>Passage 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755A71B0-F009-2043-A2FD-91BFF557A06F}"/>
              </a:ext>
            </a:extLst>
          </p:cNvPr>
          <p:cNvSpPr txBox="1"/>
          <p:nvPr/>
        </p:nvSpPr>
        <p:spPr>
          <a:xfrm>
            <a:off x="6944087" y="1670405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>
                <a:latin typeface="Helvetica" pitchFamily="2" charset="0"/>
              </a:rPr>
              <a:t>Passage 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5B4F992A-DB3B-A949-8A6F-FE89B8F08C88}"/>
              </a:ext>
            </a:extLst>
          </p:cNvPr>
          <p:cNvSpPr txBox="1"/>
          <p:nvPr/>
        </p:nvSpPr>
        <p:spPr>
          <a:xfrm>
            <a:off x="8343666" y="1670405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Passage 4</a:t>
            </a:r>
          </a:p>
        </p:txBody>
      </p:sp>
      <p:graphicFrame>
        <p:nvGraphicFramePr>
          <p:cNvPr id="49" name="Chart 48">
            <a:extLst>
              <a:ext uri="{FF2B5EF4-FFF2-40B4-BE49-F238E27FC236}">
                <a16:creationId xmlns:a16="http://schemas.microsoft.com/office/drawing/2014/main" xmlns="" id="{04F3F2F8-71DD-8F40-8C9C-8B8F8A844D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3667923"/>
              </p:ext>
            </p:extLst>
          </p:nvPr>
        </p:nvGraphicFramePr>
        <p:xfrm>
          <a:off x="3402503" y="2049005"/>
          <a:ext cx="73152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5CA6CB4D-8B51-DB4F-B547-2DC5982C44CC}"/>
              </a:ext>
            </a:extLst>
          </p:cNvPr>
          <p:cNvSpPr txBox="1"/>
          <p:nvPr/>
        </p:nvSpPr>
        <p:spPr>
          <a:xfrm rot="16200000">
            <a:off x="2967832" y="2729025"/>
            <a:ext cx="622286" cy="29238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  <a:cs typeface="Arial" panose="020B0604020202020204" pitchFamily="34" charset="0"/>
              </a:rPr>
              <a:t>OD</a:t>
            </a:r>
            <a:r>
              <a:rPr lang="en-US" sz="1300" baseline="-25000" dirty="0">
                <a:latin typeface="Helvetica" pitchFamily="2" charset="0"/>
                <a:cs typeface="Arial" panose="020B0604020202020204" pitchFamily="34" charset="0"/>
              </a:rPr>
              <a:t>600</a:t>
            </a:r>
            <a:endParaRPr lang="en-US" sz="13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18DBF07C-E58D-9B4E-BF55-CA9E50C4B7CC}"/>
              </a:ext>
            </a:extLst>
          </p:cNvPr>
          <p:cNvSpPr txBox="1"/>
          <p:nvPr/>
        </p:nvSpPr>
        <p:spPr>
          <a:xfrm>
            <a:off x="2429999" y="-131731"/>
            <a:ext cx="37061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dirty="0">
                <a:latin typeface="Helvetica" pitchFamily="2" charset="0"/>
              </a:rPr>
              <a:t>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116D2F14-2677-3D43-805C-FED6E24F09E1}"/>
              </a:ext>
            </a:extLst>
          </p:cNvPr>
          <p:cNvSpPr txBox="1"/>
          <p:nvPr/>
        </p:nvSpPr>
        <p:spPr>
          <a:xfrm>
            <a:off x="2429999" y="1721194"/>
            <a:ext cx="37061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dirty="0">
                <a:latin typeface="Helvetica" pitchFamily="2" charset="0"/>
              </a:rPr>
              <a:t>b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BD9814D5-EB98-2644-87FD-EBE88AA67F23}"/>
              </a:ext>
            </a:extLst>
          </p:cNvPr>
          <p:cNvSpPr txBox="1"/>
          <p:nvPr/>
        </p:nvSpPr>
        <p:spPr>
          <a:xfrm>
            <a:off x="4103687" y="3585417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Passage 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CAE58A2B-ED00-0C4F-9C2C-D751B5B6E826}"/>
              </a:ext>
            </a:extLst>
          </p:cNvPr>
          <p:cNvSpPr txBox="1"/>
          <p:nvPr/>
        </p:nvSpPr>
        <p:spPr>
          <a:xfrm>
            <a:off x="5515057" y="3585417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Passage 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0021B2D0-0C91-8443-AF4B-EFDF815AFD93}"/>
              </a:ext>
            </a:extLst>
          </p:cNvPr>
          <p:cNvSpPr txBox="1"/>
          <p:nvPr/>
        </p:nvSpPr>
        <p:spPr>
          <a:xfrm>
            <a:off x="6944087" y="3585417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Passage 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83FFB451-FE51-3B45-934E-E756C29D0E81}"/>
              </a:ext>
            </a:extLst>
          </p:cNvPr>
          <p:cNvSpPr txBox="1"/>
          <p:nvPr/>
        </p:nvSpPr>
        <p:spPr>
          <a:xfrm>
            <a:off x="8343666" y="3585417"/>
            <a:ext cx="973343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Passage 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B3154E9F-B386-2740-80DA-508641B15CB7}"/>
              </a:ext>
            </a:extLst>
          </p:cNvPr>
          <p:cNvSpPr txBox="1"/>
          <p:nvPr/>
        </p:nvSpPr>
        <p:spPr>
          <a:xfrm>
            <a:off x="2429999" y="3892151"/>
            <a:ext cx="35137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600" dirty="0">
                <a:latin typeface="Helvetica" pitchFamily="2" charset="0"/>
              </a:rPr>
              <a:t>c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xmlns="" id="{71374D9B-132A-F84A-8775-6D91D4424D65}"/>
              </a:ext>
            </a:extLst>
          </p:cNvPr>
          <p:cNvCxnSpPr>
            <a:cxnSpLocks/>
          </p:cNvCxnSpPr>
          <p:nvPr/>
        </p:nvCxnSpPr>
        <p:spPr>
          <a:xfrm flipV="1">
            <a:off x="3726429" y="4459416"/>
            <a:ext cx="32004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xmlns="" id="{13550EC6-F941-4846-B017-9AAFDD23C2B8}"/>
              </a:ext>
            </a:extLst>
          </p:cNvPr>
          <p:cNvCxnSpPr>
            <a:cxnSpLocks/>
          </p:cNvCxnSpPr>
          <p:nvPr/>
        </p:nvCxnSpPr>
        <p:spPr>
          <a:xfrm flipV="1">
            <a:off x="10543532" y="4459416"/>
            <a:ext cx="32004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xmlns="" id="{5522805C-FCFA-2744-BD04-C1CA4F2602DF}"/>
              </a:ext>
            </a:extLst>
          </p:cNvPr>
          <p:cNvCxnSpPr>
            <a:cxnSpLocks/>
          </p:cNvCxnSpPr>
          <p:nvPr/>
        </p:nvCxnSpPr>
        <p:spPr>
          <a:xfrm flipV="1">
            <a:off x="9183132" y="4459416"/>
            <a:ext cx="32004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xmlns="" id="{1F8C6411-BA4C-A44C-8234-DEB7981C36BE}"/>
              </a:ext>
            </a:extLst>
          </p:cNvPr>
          <p:cNvCxnSpPr>
            <a:cxnSpLocks/>
          </p:cNvCxnSpPr>
          <p:nvPr/>
        </p:nvCxnSpPr>
        <p:spPr>
          <a:xfrm flipV="1">
            <a:off x="7812443" y="4459416"/>
            <a:ext cx="32004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xmlns="" id="{C08751F4-B619-CD46-84C9-BCB035C4A786}"/>
              </a:ext>
            </a:extLst>
          </p:cNvPr>
          <p:cNvCxnSpPr>
            <a:cxnSpLocks/>
          </p:cNvCxnSpPr>
          <p:nvPr/>
        </p:nvCxnSpPr>
        <p:spPr>
          <a:xfrm flipV="1">
            <a:off x="6454545" y="4459416"/>
            <a:ext cx="32004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xmlns="" id="{EE7EFDA9-12A7-F541-8A49-D9FD161C1A7F}"/>
              </a:ext>
            </a:extLst>
          </p:cNvPr>
          <p:cNvCxnSpPr>
            <a:cxnSpLocks/>
          </p:cNvCxnSpPr>
          <p:nvPr/>
        </p:nvCxnSpPr>
        <p:spPr>
          <a:xfrm flipV="1">
            <a:off x="5094055" y="4459416"/>
            <a:ext cx="32004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ight Bracket 1">
            <a:extLst>
              <a:ext uri="{FF2B5EF4-FFF2-40B4-BE49-F238E27FC236}">
                <a16:creationId xmlns:a16="http://schemas.microsoft.com/office/drawing/2014/main" xmlns="" id="{93744C5D-6106-9844-826B-7AF398EB1BF2}"/>
              </a:ext>
            </a:extLst>
          </p:cNvPr>
          <p:cNvSpPr/>
          <p:nvPr/>
        </p:nvSpPr>
        <p:spPr>
          <a:xfrm rot="16200000">
            <a:off x="6824895" y="1632286"/>
            <a:ext cx="146735" cy="5365128"/>
          </a:xfrm>
          <a:prstGeom prst="rightBracket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3E81D3CE-C3D2-AA4C-A439-84B84172A62A}"/>
              </a:ext>
            </a:extLst>
          </p:cNvPr>
          <p:cNvSpPr txBox="1"/>
          <p:nvPr/>
        </p:nvSpPr>
        <p:spPr>
          <a:xfrm>
            <a:off x="5551338" y="3989502"/>
            <a:ext cx="269227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>
                <a:latin typeface="Helvetica" pitchFamily="2" charset="0"/>
              </a:rPr>
              <a:t>High-expressing </a:t>
            </a:r>
            <a:r>
              <a:rPr lang="en-US" sz="1300" i="1" dirty="0">
                <a:latin typeface="Helvetica" pitchFamily="2" charset="0"/>
              </a:rPr>
              <a:t>A. fabrum</a:t>
            </a:r>
            <a:r>
              <a:rPr lang="en-US" sz="1300" dirty="0">
                <a:latin typeface="Helvetica" pitchFamily="2" charset="0"/>
              </a:rPr>
              <a:t> strains</a:t>
            </a:r>
          </a:p>
        </p:txBody>
      </p:sp>
    </p:spTree>
    <p:extLst>
      <p:ext uri="{BB962C8B-B14F-4D97-AF65-F5344CB8AC3E}">
        <p14:creationId xmlns:p14="http://schemas.microsoft.com/office/powerpoint/2010/main" val="3135655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5</TotalTime>
  <Words>33</Words>
  <Application>Microsoft Office PowerPoint</Application>
  <PresentationFormat>Custom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Benedict</dc:creator>
  <cp:lastModifiedBy>Bhuvanaeshwari K.</cp:lastModifiedBy>
  <cp:revision>8</cp:revision>
  <dcterms:created xsi:type="dcterms:W3CDTF">2021-10-19T09:46:44Z</dcterms:created>
  <dcterms:modified xsi:type="dcterms:W3CDTF">2021-10-30T04:28:00Z</dcterms:modified>
</cp:coreProperties>
</file>